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670675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670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88936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778200" y="0"/>
            <a:ext cx="288936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853560" y="744120"/>
            <a:ext cx="496116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66360" y="4714560"/>
            <a:ext cx="533556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88936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778200" y="9427680"/>
            <a:ext cx="288936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82F150-B3B6-4395-8E21-03B56A8E5D4B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ldImg"/>
          </p:nvPr>
        </p:nvSpPr>
        <p:spPr>
          <a:xfrm>
            <a:off x="853920" y="744480"/>
            <a:ext cx="4961160" cy="3722760"/>
          </a:xfrm>
          <a:prstGeom prst="rect">
            <a:avLst/>
          </a:prstGeom>
          <a:ln w="0">
            <a:noFill/>
          </a:ln>
        </p:spPr>
      </p:sp>
      <p:sp>
        <p:nvSpPr>
          <p:cNvPr id="55" name="PlaceHolder 2"/>
          <p:cNvSpPr>
            <a:spLocks noGrp="1"/>
          </p:cNvSpPr>
          <p:nvPr>
            <p:ph type="body"/>
          </p:nvPr>
        </p:nvSpPr>
        <p:spPr>
          <a:xfrm>
            <a:off x="666360" y="4714560"/>
            <a:ext cx="533556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灯片编号占位符 3"/>
          <p:cNvSpPr/>
          <p:nvPr/>
        </p:nvSpPr>
        <p:spPr>
          <a:xfrm>
            <a:off x="3778200" y="9428040"/>
            <a:ext cx="288936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250415-DADA-4D64-B9C1-766F1BD17421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A6E228-649E-4C5F-983A-AB33ED2EECE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B39AC9-9F26-45EA-B4D8-E8B23F0838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A50EB9-E503-414F-86D4-6F17A05287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B6D11B-4022-488D-97ED-07538B653D1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FE0437-1831-4401-AD56-F437BF7034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EC9552-41E2-4378-9B10-B913495989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8395BD-3FE7-427D-B8E0-3847532AF6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5239B1-71ED-4B9F-AD95-E6599B6BD9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E22EB5-DDA8-43E7-A273-041C3C5B51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585AAA-118B-4E28-9462-5109AFF795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4E4AFA-4A57-4E77-9CE8-3FC0DC0A98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8DD608-F639-4C3A-BF2E-2AABEA248F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542A38-8FBD-40EA-9C4C-8AFCD695272A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179280" y="546120"/>
          <a:ext cx="8712360" cy="6184800"/>
        </p:xfrm>
        <a:graphic>
          <a:graphicData uri="http://schemas.openxmlformats.org/drawingml/2006/table">
            <a:tbl>
              <a:tblPr/>
              <a:tblGrid>
                <a:gridCol w="647640"/>
                <a:gridCol w="649440"/>
                <a:gridCol w="574560"/>
                <a:gridCol w="576360"/>
                <a:gridCol w="576360"/>
                <a:gridCol w="698400"/>
                <a:gridCol w="560520"/>
                <a:gridCol w="561960"/>
                <a:gridCol w="560160"/>
                <a:gridCol w="569880"/>
                <a:gridCol w="721080"/>
                <a:gridCol w="438120"/>
                <a:gridCol w="642960"/>
                <a:gridCol w="496800"/>
                <a:gridCol w="438120"/>
              </a:tblGrid>
              <a:tr h="187200">
                <a:tc rowSpan="2"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N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ho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N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ho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N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ho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7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212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.8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6.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.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1.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1-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.2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1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2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.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4.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.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1.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1-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.4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1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2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564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.8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6.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.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1.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1-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8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9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4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3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4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7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.6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398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9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.4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.8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2.7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2.0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4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0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9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3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564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8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2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4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0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169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744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8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2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4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169u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1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9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4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.3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169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.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169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0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9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7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.3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7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5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6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3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7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5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564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6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3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7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5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0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7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6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9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1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1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7-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5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0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7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5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1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1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2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7-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5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9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7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6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9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1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1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7-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5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564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7-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6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1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1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2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7-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5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7-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7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4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1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1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8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1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0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3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4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7-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6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2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1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1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8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7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5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7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4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564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171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.9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.2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3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8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1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5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7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4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171q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.9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.2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3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8-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1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0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3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4-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744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9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8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4-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9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4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4-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2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1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9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4-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564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1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.2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1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1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4-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1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.2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1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1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4-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1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.2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1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1-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1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4-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7200"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1-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.4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1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1-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4-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矩形 2"/>
          <p:cNvSpPr/>
          <p:nvPr/>
        </p:nvSpPr>
        <p:spPr>
          <a:xfrm>
            <a:off x="6589800" y="9360"/>
            <a:ext cx="2239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tabl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"/>
          <p:cNvGraphicFramePr/>
          <p:nvPr/>
        </p:nvGraphicFramePr>
        <p:xfrm>
          <a:off x="1116000" y="907920"/>
          <a:ext cx="5904000" cy="2644920"/>
        </p:xfrm>
        <a:graphic>
          <a:graphicData uri="http://schemas.openxmlformats.org/drawingml/2006/table">
            <a:tbl>
              <a:tblPr/>
              <a:tblGrid>
                <a:gridCol w="758880"/>
                <a:gridCol w="484200"/>
                <a:gridCol w="620640"/>
                <a:gridCol w="449280"/>
                <a:gridCol w="482760"/>
                <a:gridCol w="795240"/>
                <a:gridCol w="482400"/>
                <a:gridCol w="534960"/>
                <a:gridCol w="503280"/>
                <a:gridCol w="792360"/>
              </a:tblGrid>
              <a:tr h="174600">
                <a:tc rowSpan="2"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N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ho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N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ho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76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4-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2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74600"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4-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2-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3440"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3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6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3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3440"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6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4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2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6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4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4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3440"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6-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0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7.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5520"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169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51.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5.7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2.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3440"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.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3440"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2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51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2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51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240" rIns="5724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240" marR="57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1" name="矩形 2"/>
          <p:cNvSpPr/>
          <p:nvPr/>
        </p:nvSpPr>
        <p:spPr>
          <a:xfrm>
            <a:off x="5811840" y="9360"/>
            <a:ext cx="3262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table 3 continu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矩形 2"/>
          <p:cNvSpPr/>
          <p:nvPr/>
        </p:nvSpPr>
        <p:spPr>
          <a:xfrm>
            <a:off x="1044720" y="3573360"/>
            <a:ext cx="358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profiles expressed in sequence reads per million genome read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矩形 2"/>
          <p:cNvSpPr/>
          <p:nvPr/>
        </p:nvSpPr>
        <p:spPr>
          <a:xfrm>
            <a:off x="1043640" y="3773520"/>
            <a:ext cx="3497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NAs in fold mean the miRNAs identified by degradome sequencin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02T05:22:18Z</dcterms:created>
  <dc:creator>MC SYSTEM</dc:creator>
  <dc:description/>
  <dc:language>en-US</dc:language>
  <cp:lastModifiedBy>MC SYSTEM</cp:lastModifiedBy>
  <dcterms:modified xsi:type="dcterms:W3CDTF">2011-06-19T01:17:09Z</dcterms:modified>
  <cp:revision>35</cp:revision>
  <dc:subject/>
  <dc:title>幻灯片 1</dc:title>
</cp:coreProperties>
</file>